
<file path=[Content_Types].xml><?xml version="1.0" encoding="utf-8"?>
<Types xmlns="http://schemas.openxmlformats.org/package/2006/content-types">
  <Default Extension="png" ContentType="image/png"/>
  <Default Extension="tiff" ContentType="image/tiff"/>
  <Default Extension="wdp" ContentType="image/vnd.ms-photo"/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60" r:id="rId3"/>
    <p:sldId id="269" r:id="rId4"/>
    <p:sldId id="268" r:id="rId5"/>
    <p:sldId id="270" r:id="rId6"/>
  </p:sldIdLst>
  <p:sldSz cx="12192000" cy="6858000"/>
  <p:notesSz cx="6858000" cy="9144000"/>
  <p:custDataLst>
    <p:tags r:id="rId12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614" y="6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handoutMaster" Target="handoutMasters/handoutMaster1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gs" Target="tags/tag67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63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microsoft.com/office/2007/relationships/hdphoto" Target="../media/image2.wdp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4.xml"/><Relationship Id="rId4" Type="http://schemas.microsoft.com/office/2007/relationships/hdphoto" Target="../media/image9.wdp"/><Relationship Id="rId3" Type="http://schemas.openxmlformats.org/officeDocument/2006/relationships/image" Target="../media/image8.png"/><Relationship Id="rId2" Type="http://schemas.openxmlformats.org/officeDocument/2006/relationships/image" Target="../media/image7.jpeg"/><Relationship Id="rId1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5.xml"/><Relationship Id="rId1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66.xml"/><Relationship Id="rId4" Type="http://schemas.openxmlformats.org/officeDocument/2006/relationships/image" Target="../media/image14.png"/><Relationship Id="rId3" Type="http://schemas.openxmlformats.org/officeDocument/2006/relationships/image" Target="../media/image13.jpeg"/><Relationship Id="rId2" Type="http://schemas.microsoft.com/office/2007/relationships/hdphoto" Target="../media/image12.wdp"/><Relationship Id="rId1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colorTemperature colorTemp="4700"/>
                    </a14:imgEffect>
                    <a14:imgEffect>
                      <a14:saturation sa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2784" r="20719" b="20286"/>
          <a:stretch>
            <a:fillRect/>
          </a:stretch>
        </p:blipFill>
        <p:spPr>
          <a:xfrm>
            <a:off x="1186815" y="3783012"/>
            <a:ext cx="2091275" cy="252209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96" r="46609" b="14368"/>
          <a:stretch>
            <a:fillRect/>
          </a:stretch>
        </p:blipFill>
        <p:spPr>
          <a:xfrm>
            <a:off x="4068852" y="451898"/>
            <a:ext cx="2161541" cy="254000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763"/>
          <a:stretch>
            <a:fillRect/>
          </a:stretch>
        </p:blipFill>
        <p:spPr>
          <a:xfrm>
            <a:off x="1022282" y="513584"/>
            <a:ext cx="2091275" cy="252209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6336507" y="2243574"/>
            <a:ext cx="5401310" cy="3683635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algn="just"/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. S1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Construction of Δ</a:t>
            </a:r>
            <a:r>
              <a:rPr lang="en-US" altLang="zh-CN" sz="1600" i="1" dirty="0" err="1">
                <a:latin typeface="Times New Roman" panose="02020603050405020304" charset="0"/>
                <a:cs typeface="Times New Roman" panose="02020603050405020304" charset="0"/>
              </a:rPr>
              <a:t>motA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-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3378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strain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  <a:p>
            <a:pPr algn="just"/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</a:rPr>
              <a:t>A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: Amplification of upstream homologous arm and downstream homologous arm M:DL2000 marker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1: upstream homologous arm, 2: downstream homologous arms  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  <a:p>
            <a:pPr algn="just"/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B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,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C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: The recombinant products were transformed into PCR results of </a:t>
            </a:r>
            <a:r>
              <a:rPr lang="en-US" altLang="zh-CN" sz="1600" i="1" dirty="0" err="1">
                <a:latin typeface="Times New Roman" panose="02020603050405020304" charset="0"/>
                <a:cs typeface="Times New Roman" panose="02020603050405020304" charset="0"/>
              </a:rPr>
              <a:t>Ecoli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DH5α respectively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:DL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5000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arker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3,4,5: PCR results of upstream homologous arm were verified, 6,7,8: PCR results of downstream homologous arms were verified 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just"/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D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: Mutant screening results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  <a:p>
            <a:pPr algn="just"/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:DL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5000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marker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9: Wild strain as control, 10: Mutant strain after homologous recombination double exchange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47395" y="62230"/>
            <a:ext cx="1009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861435" y="3244850"/>
            <a:ext cx="1009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D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81990" y="3253105"/>
            <a:ext cx="1009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C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861435" y="16510"/>
            <a:ext cx="1009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278255" y="21082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M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23730" y="1332993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75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19100" y="1595120"/>
            <a:ext cx="656590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5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869440" y="21082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1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2340610" y="21653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2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528564" y="1675110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75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525665" y="1954014"/>
            <a:ext cx="656590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5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277295" y="162463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M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869440" y="336740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6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722749" y="15960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3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5016003" y="348459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9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570453" y="348459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10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2340610" y="336740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7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5196806" y="15960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4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285875" y="336740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M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4438719" y="3449720"/>
            <a:ext cx="471170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M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679471" y="4706440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75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678836" y="4973320"/>
            <a:ext cx="656590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5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3660140" y="4520414"/>
            <a:ext cx="85788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30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423730" y="1070866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bp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3660140" y="4785661"/>
            <a:ext cx="85788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20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3731260" y="3761105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bp</a:t>
            </a:r>
            <a:endParaRPr lang="en-US" altLang="zh-CN" sz="14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681990" y="4358916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bp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518087" y="1308596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bp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666999" y="15960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865437" y="3367404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8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1" name="图片 4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25" r="78788" b="15145"/>
          <a:stretch>
            <a:fillRect/>
          </a:stretch>
        </p:blipFill>
        <p:spPr>
          <a:xfrm>
            <a:off x="4308307" y="3778266"/>
            <a:ext cx="1818705" cy="2526013"/>
          </a:xfrm>
          <a:prstGeom prst="rect">
            <a:avLst/>
          </a:prstGeom>
        </p:spPr>
      </p:pic>
    </p:spTree>
    <p:custDataLst>
      <p:tags r:id="rId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/>
        </p:nvSpPr>
        <p:spPr>
          <a:xfrm>
            <a:off x="675005" y="4515485"/>
            <a:ext cx="10897235" cy="1692910"/>
          </a:xfrm>
          <a:prstGeom prst="rect">
            <a:avLst/>
          </a:prstGeom>
          <a:noFill/>
        </p:spPr>
        <p:txBody>
          <a:bodyPr wrap="square" rtlCol="0" anchor="t">
            <a:noAutofit/>
          </a:bodyPr>
          <a:lstStyle/>
          <a:p>
            <a:pPr algn="just"/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. S2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Construction of complementary strain of Δ</a:t>
            </a:r>
            <a:r>
              <a:rPr lang="en-US" sz="16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otA</a:t>
            </a:r>
            <a:r>
              <a:rPr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3378</a:t>
            </a:r>
            <a:r>
              <a:rPr 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</a:t>
            </a:r>
            <a:r>
              <a:rPr lang="zh-CN" altLang="en-US" sz="16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A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: The Δ</a:t>
            </a:r>
            <a:r>
              <a:rPr lang="en-US" altLang="zh-CN" sz="16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motA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3378 screening results of gentamicin resistance genes were eliminated. M:DL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5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000 marker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1: Δ</a:t>
            </a:r>
            <a:r>
              <a:rPr lang="en-US" altLang="zh-CN" sz="16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otA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3378, 2: Elimination of Δ</a:t>
            </a:r>
            <a:r>
              <a:rPr lang="en-US" altLang="zh-CN" sz="16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otA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3378 of gentamicin resistance gene  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B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: Verification results of successful ligation of recombinant plasmids 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:DL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2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000 marker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 3,4: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Complementary sequences of Δ</a:t>
            </a:r>
            <a:r>
              <a:rPr lang="en-US" altLang="zh-CN" sz="16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motA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3378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C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: Verification results of Recombinant plasmid transferred into Δ</a:t>
            </a:r>
            <a:r>
              <a:rPr lang="en-US" altLang="zh-CN" sz="1600" i="1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otA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3378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M:DL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5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000 marker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5,6: 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Complementary sequences of Δ</a:t>
            </a:r>
            <a:r>
              <a:rPr lang="en-US" altLang="zh-CN" sz="1600" i="1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motA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-3378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807085" y="75057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M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629410" y="75057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1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451735" y="75057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2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842503" y="756539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3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571120" y="757428"/>
            <a:ext cx="423240" cy="318134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4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9203055" y="732127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M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9160510" y="75057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0500360" y="75057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6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9830435" y="75057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5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988781" y="75057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M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257810" y="1068705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bp</a:t>
            </a:r>
            <a:endParaRPr lang="en-US" altLang="zh-CN" sz="14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047490" y="1136650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bp</a:t>
            </a:r>
            <a:endParaRPr lang="en-US" altLang="zh-CN" sz="14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8293392" y="1285019"/>
            <a:ext cx="65595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bp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62118" y="1369486"/>
            <a:ext cx="85788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30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56844" y="1773672"/>
            <a:ext cx="85788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20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995737" y="1462813"/>
            <a:ext cx="85788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20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009386" y="1922582"/>
            <a:ext cx="85788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10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8284212" y="1736034"/>
            <a:ext cx="85788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20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8281506" y="1918452"/>
            <a:ext cx="857885" cy="2895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1500</a:t>
            </a:r>
            <a:endParaRPr lang="en-US" altLang="zh-CN" sz="14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34975" y="321310"/>
            <a:ext cx="1009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4199255" y="382270"/>
            <a:ext cx="1009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8428990" y="314325"/>
            <a:ext cx="10096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Times New Roman" panose="02020603050405020304" charset="0"/>
                <a:cs typeface="Times New Roman" panose="02020603050405020304" charset="0"/>
              </a:rPr>
              <a:t>C</a:t>
            </a:r>
            <a:endParaRPr lang="en-US" altLang="zh-CN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9689" r="70981" b="35379"/>
          <a:stretch>
            <a:fillRect/>
          </a:stretch>
        </p:blipFill>
        <p:spPr>
          <a:xfrm>
            <a:off x="8933815" y="1056675"/>
            <a:ext cx="2103755" cy="2315373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8831"/>
          <a:stretch>
            <a:fillRect/>
          </a:stretch>
        </p:blipFill>
        <p:spPr>
          <a:xfrm>
            <a:off x="4695907" y="1100047"/>
            <a:ext cx="948735" cy="220634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28" r="64141"/>
          <a:stretch>
            <a:fillRect/>
          </a:stretch>
        </p:blipFill>
        <p:spPr>
          <a:xfrm>
            <a:off x="5644642" y="1100047"/>
            <a:ext cx="1438181" cy="220634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7896" r="77431" b="25291"/>
          <a:stretch>
            <a:fillRect/>
          </a:stretch>
        </p:blipFill>
        <p:spPr>
          <a:xfrm>
            <a:off x="862647" y="1075562"/>
            <a:ext cx="2056977" cy="2506549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3245485" y="5552440"/>
            <a:ext cx="60960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. S3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Glucose standard curve</a:t>
            </a:r>
            <a:endParaRPr sz="1600" dirty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6" name="图片 5" descr="胞外多糖标准曲线"/>
          <p:cNvPicPr>
            <a:picLocks noChangeAspect="1"/>
          </p:cNvPicPr>
          <p:nvPr/>
        </p:nvPicPr>
        <p:blipFill>
          <a:blip r:embed="rId1"/>
          <a:srcRect l="9144" t="7751" r="8340" b="4067"/>
          <a:stretch>
            <a:fillRect/>
          </a:stretch>
        </p:blipFill>
        <p:spPr>
          <a:xfrm>
            <a:off x="2615565" y="734060"/>
            <a:ext cx="6452235" cy="481838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 cstate="print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40000" contrast="-4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7459"/>
          <a:stretch>
            <a:fillRect/>
          </a:stretch>
        </p:blipFill>
        <p:spPr>
          <a:xfrm rot="16200000">
            <a:off x="6800510" y="396817"/>
            <a:ext cx="3119085" cy="68580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4502150" y="5534660"/>
            <a:ext cx="7201535" cy="13220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. S4</a:t>
            </a:r>
            <a:r>
              <a:rPr lang="zh-CN" altLang="en-US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A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Nodulation of some chickpea plants inoculated with different strains 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B 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PCR profiles of nodules from competitive nodulation assays 1:PCR amplification band of Δ</a:t>
            </a:r>
            <a:r>
              <a:rPr lang="en-US" altLang="zh-CN" sz="1600" i="1" dirty="0">
                <a:latin typeface="Times New Roman" panose="02020603050405020304" charset="0"/>
                <a:cs typeface="Times New Roman" panose="02020603050405020304" charset="0"/>
              </a:rPr>
              <a:t>motA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-3378 2:PCR amplification band of WT-3378 </a:t>
            </a:r>
            <a:r>
              <a:rPr lang="en-US" altLang="zh-CN" sz="1600" b="1" dirty="0">
                <a:latin typeface="Times New Roman" panose="02020603050405020304" charset="0"/>
                <a:cs typeface="Times New Roman" panose="02020603050405020304" charset="0"/>
              </a:rPr>
              <a:t>C</a:t>
            </a:r>
            <a:r>
              <a:rPr lang="en-US" altLang="zh-CN" sz="1600" dirty="0">
                <a:latin typeface="Times New Roman" panose="02020603050405020304" charset="0"/>
                <a:cs typeface="Times New Roman" panose="02020603050405020304" charset="0"/>
              </a:rPr>
              <a:t> Results of BOX-PCR fingerprint of partial competitive nodulation 3: BOX-PCR fingerprint of CCBAU 83963  4: BOX-PCR fingerprint of USDA 3378  M: DL 5000 marker</a:t>
            </a:r>
            <a:endParaRPr lang="en-US" altLang="zh-CN" sz="1600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930694" y="198045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M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10920124" y="18852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6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1</a:t>
            </a:r>
            <a:endParaRPr lang="en-US" altLang="zh-CN" sz="1600" dirty="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1232267" y="188554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2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4502150" y="188595"/>
            <a:ext cx="4286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85402" y="198079"/>
            <a:ext cx="46654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84" t="872" r="28899" b="17102"/>
          <a:stretch>
            <a:fillRect/>
          </a:stretch>
        </p:blipFill>
        <p:spPr>
          <a:xfrm>
            <a:off x="598805" y="359410"/>
            <a:ext cx="3282315" cy="562546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 rot="20456120">
            <a:off x="908578" y="6177009"/>
            <a:ext cx="1056005" cy="3219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T-3378</a:t>
            </a:r>
            <a:endParaRPr lang="en-US" altLang="zh-CN" sz="14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20253183">
            <a:off x="1390057" y="6134805"/>
            <a:ext cx="1463675" cy="3219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Δ</a:t>
            </a:r>
            <a:r>
              <a:rPr lang="en-US" altLang="zh-CN" sz="1400" i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A</a:t>
            </a:r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3378</a:t>
            </a:r>
            <a:endParaRPr lang="en-US" altLang="zh-CN" sz="14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 rot="20311508">
            <a:off x="2065333" y="6134805"/>
            <a:ext cx="1463675" cy="3219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Δ</a:t>
            </a:r>
            <a:r>
              <a:rPr lang="en-US" altLang="zh-CN" sz="1400" i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motA</a:t>
            </a:r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-3378-C</a:t>
            </a:r>
            <a:endParaRPr lang="en-US" altLang="zh-CN" sz="14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20229314">
            <a:off x="2738946" y="6120052"/>
            <a:ext cx="1463675" cy="32194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400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T-8363</a:t>
            </a:r>
            <a:endParaRPr lang="en-US" altLang="zh-CN" sz="1400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12" name="直接连接符 11"/>
          <p:cNvCxnSpPr/>
          <p:nvPr/>
        </p:nvCxnSpPr>
        <p:spPr>
          <a:xfrm flipH="1">
            <a:off x="1068070" y="3840480"/>
            <a:ext cx="5080" cy="1137920"/>
          </a:xfrm>
          <a:prstGeom prst="line">
            <a:avLst/>
          </a:prstGeom>
          <a:ln w="31750" cap="rnd">
            <a:solidFill>
              <a:srgbClr val="FF0000"/>
            </a:solidFill>
            <a:round/>
          </a:ln>
        </p:spPr>
        <p:style>
          <a:lnRef idx="0">
            <a:srgbClr val="FFFFFF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 rot="16200000">
            <a:off x="244475" y="4194810"/>
            <a:ext cx="10769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100 mm</a:t>
            </a:r>
            <a:endParaRPr lang="en-US" altLang="zh-CN" b="1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4"/>
          <a:srcRect l="35979"/>
          <a:stretch>
            <a:fillRect/>
          </a:stretch>
        </p:blipFill>
        <p:spPr>
          <a:xfrm rot="16200000">
            <a:off x="7583170" y="-2136140"/>
            <a:ext cx="1468120" cy="6772910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4502150" y="1993900"/>
            <a:ext cx="4286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C</a:t>
            </a:r>
            <a:endParaRPr lang="en-US" altLang="zh-CN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930694" y="1984300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M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1232267" y="1993859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4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0919847" y="1993859"/>
            <a:ext cx="471170" cy="3181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/>
            <a:r>
              <a:rPr lang="en-US" altLang="zh-CN" sz="160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3</a:t>
            </a:r>
            <a:endParaRPr lang="en-US" altLang="zh-CN" sz="1600">
              <a:solidFill>
                <a:srgbClr val="FF0000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p="http://schemas.openxmlformats.org/presentationml/2006/main">
  <p:tag name="COMMONDATA" val="eyJoZGlkIjoiZjdiNjhkMjIxNDVlZGFhMDYzNGMwNjI1Nzk0ZDBlZDI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12</Words>
  <Application>WPS 演示</Application>
  <PresentationFormat>宽屏</PresentationFormat>
  <Paragraphs>14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张俊杰</cp:lastModifiedBy>
  <cp:revision>188</cp:revision>
  <dcterms:created xsi:type="dcterms:W3CDTF">2019-06-19T02:08:00Z</dcterms:created>
  <dcterms:modified xsi:type="dcterms:W3CDTF">2025-11-10T08:20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3542</vt:lpwstr>
  </property>
  <property fmtid="{D5CDD505-2E9C-101B-9397-08002B2CF9AE}" pid="3" name="ICV">
    <vt:lpwstr>C000225F644A4C86A7508468BDDAA3B9_12</vt:lpwstr>
  </property>
</Properties>
</file>